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83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46C814-95AA-46B2-92D9-630E0F38CE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E632926-212A-403B-A3AF-EC36298EB8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F73433-E19C-4A01-B12C-3E9798717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EAFD45-45AD-42B7-98BC-4302C1D6E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D6DB30-0E44-4D93-9ADC-3F505DADE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503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CBA01D-7364-4706-A54D-416A583D85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859C03B-271E-41D1-B94A-7210F676E1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141FF5-8B85-4B8D-A9C6-5E1A20AD0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52A4F4-0F30-4E8E-8D40-59FB7F861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099CDF-CFB8-4AD9-B650-4CAB605E4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49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A82F2AC-9BF6-494E-BDA4-DA864C5141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E4E7B3-F3B6-4144-B2B5-15ED5ED1E6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A1F61E-0964-4BFB-8313-B09A1DD0D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34EF51-D129-49C2-8081-D07694959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9AA74D9-7333-45E7-8D16-249245FA3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6323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454C78-58A7-4420-BAC0-0ECC9D525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F03E3B7-7431-4D92-97DB-D132391FBF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6AA7CF-D26B-43AA-B410-F349DD105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BFCB01-A30B-4BC5-9190-2369C4339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846BE7-088B-431E-A5E8-2B2C87E33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0329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2A09ED-A530-4CA4-9161-FAF9445877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13FA8C-3C01-4605-AE9D-CB316B54E7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659D11-74ED-498F-9916-D3333B24C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7081AF-1845-4DBE-935D-F598EAC06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6829AE-3917-4E24-B3A9-A60887579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107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18F0A0-C0E1-4A29-B513-DE6E4756FA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C02FE5-80F1-4FA1-8E15-FC595AD895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D8A5AEF-3DF6-413A-A92B-310DA4316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72CDCA-4503-475F-8BBC-D929E0FDE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7A7F82E-DC9D-46C5-AC09-22D316209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E7C3249-54B0-400B-8D71-34CADD426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144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A65932-A7C9-4899-B36C-8A04D815B1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6C29C10-C19A-4104-B016-95072266C6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0B2EFF8-BDAF-4AC5-B16B-F371C5B0D5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ED32F29-8EC3-4957-B76B-7ADBA9BD67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5CE52CF-9BD6-4001-9CDD-BEE24FF662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4A52063-4715-4D34-93AB-4845F314C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4AFF2A2-9F7A-4BB1-A799-66B01D09E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3B5BF99-9C9E-4704-8326-41665EB6A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931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B60C93-2524-4173-A098-4082AF80E4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53E6819-EF65-4C02-B81A-202E067FC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B46F040-447B-45FF-BEC3-57CF42607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33C72A1-3CDC-4558-8D07-ED9E71BA4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4672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C8E5B02-E8EC-4F65-A9D0-9E1BFA26C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5995392-6C9B-4744-A199-53BC7F5A7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D326153-ABAC-48F2-9FF6-A196A578D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0525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BA6B99-08D8-46B8-B8DA-84458A8017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8AC9E4-6783-4887-BA9E-31418BC4A3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6DD7A39-4298-44E6-86E2-19A6F1E603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8B3F79E-4116-4F73-859F-8670A5026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4231887-BC32-470B-9D96-73BE62613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E2B57D-DDB7-4277-9E29-2CA3E6037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9980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7D8FC4-EDBB-498D-9261-71AC2BBB4B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86A2261-4848-4F38-8833-EB0772892A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DBC3080-96EF-4A28-932A-22CB24A33E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4CED105-2E98-4D43-9FE5-B67FF8C61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C8616A3-5FCA-4691-8497-FE09E4961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9C3771C-28B8-46A5-A433-DFB5900F3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0105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72DECCC-93D8-44B7-8128-1C450BA960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977AD00-1597-4247-898E-80A642E860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21B312-228D-484E-894F-F462B53E21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EE299F-A619-42B7-A9BD-DE9BE52E2CBD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879E6E-A9F4-489C-868D-198475FDFA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579843-9FAC-48EF-B9EC-B5954563EE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874C47-BFD0-4B66-8560-BF68DE6F21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5138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40695A87-74F8-4F76-A3D6-FDA70CDBCB5F}"/>
              </a:ext>
            </a:extLst>
          </p:cNvPr>
          <p:cNvGrpSpPr/>
          <p:nvPr/>
        </p:nvGrpSpPr>
        <p:grpSpPr>
          <a:xfrm>
            <a:off x="3329561" y="1175635"/>
            <a:ext cx="5278120" cy="2665866"/>
            <a:chOff x="3329561" y="1175635"/>
            <a:chExt cx="5278120" cy="2665866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C88391FC-CBC5-40B5-9B13-725EE0644098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29561" y="1175635"/>
              <a:ext cx="5278120" cy="184086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BBF948EE-EA0E-4E73-A25B-8ED81C23AAB2}"/>
                </a:ext>
              </a:extLst>
            </p:cNvPr>
            <p:cNvSpPr txBox="1"/>
            <p:nvPr/>
          </p:nvSpPr>
          <p:spPr>
            <a:xfrm>
              <a:off x="3470157" y="3102837"/>
              <a:ext cx="4996928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Fig. S1. Effects of UV irradiation time on </a:t>
              </a:r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GelMA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hydrogel properties. (A) Photographs of </a:t>
              </a:r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GelMA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hydrogels. (B) Storage moduli of </a:t>
              </a:r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GelMA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hydrogels.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28289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1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 Chen</dc:creator>
  <cp:lastModifiedBy>Cheng Chen</cp:lastModifiedBy>
  <cp:revision>2</cp:revision>
  <dcterms:created xsi:type="dcterms:W3CDTF">2019-12-06T07:24:00Z</dcterms:created>
  <dcterms:modified xsi:type="dcterms:W3CDTF">2019-12-11T01:43:34Z</dcterms:modified>
</cp:coreProperties>
</file>